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8" autoAdjust="0"/>
    <p:restoredTop sz="94660"/>
  </p:normalViewPr>
  <p:slideViewPr>
    <p:cSldViewPr snapToGrid="0">
      <p:cViewPr varScale="1">
        <p:scale>
          <a:sx n="62" d="100"/>
          <a:sy n="62" d="100"/>
        </p:scale>
        <p:origin x="199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427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294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619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834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235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990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070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47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4360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72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991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195B8-90AB-4FD1-9B2F-8972E2D378F3}" type="datetimeFigureOut">
              <a:rPr kumimoji="1" lang="ja-JP" altLang="en-US" smtClean="0"/>
              <a:t>2023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34EB7-B479-4A4A-8143-DC4B793F86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602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屋外, 水, 飛ぶ, 男 が含まれている画像&#10;&#10;自動的に生成された説明">
            <a:extLst>
              <a:ext uri="{FF2B5EF4-FFF2-40B4-BE49-F238E27FC236}">
                <a16:creationId xmlns:a16="http://schemas.microsoft.com/office/drawing/2014/main" id="{50C2E34E-0389-26D7-9AEC-FC778431FD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944" y="586961"/>
            <a:ext cx="2147273" cy="357166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8A2E5EF-6FE2-2115-B3C9-E2C15B8B290D}"/>
              </a:ext>
            </a:extLst>
          </p:cNvPr>
          <p:cNvSpPr txBox="1"/>
          <p:nvPr/>
        </p:nvSpPr>
        <p:spPr>
          <a:xfrm>
            <a:off x="1802318" y="4241585"/>
            <a:ext cx="44294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of 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</a:t>
            </a:r>
            <a:r>
              <a:rPr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 descr="屋内, 座る, 水, 小さい が含まれている画像&#10;&#10;自動的に生成された説明">
            <a:extLst>
              <a:ext uri="{FF2B5EF4-FFF2-40B4-BE49-F238E27FC236}">
                <a16:creationId xmlns:a16="http://schemas.microsoft.com/office/drawing/2014/main" id="{6265A620-F413-480B-2734-7B7D8C9C10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2568" y="4953000"/>
            <a:ext cx="3969919" cy="313374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34C806D-A046-9CF5-7D8A-AF36C1BE230C}"/>
              </a:ext>
            </a:extLst>
          </p:cNvPr>
          <p:cNvSpPr txBox="1"/>
          <p:nvPr/>
        </p:nvSpPr>
        <p:spPr>
          <a:xfrm>
            <a:off x="1382568" y="8358946"/>
            <a:ext cx="44294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of </a:t>
            </a:r>
            <a:r>
              <a:rPr kumimoji="1"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pplementary Figure 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0517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白黒の写真にテキストが書いてある&#10;&#10;低い精度で自動的に生成された説明">
            <a:extLst>
              <a:ext uri="{FF2B5EF4-FFF2-40B4-BE49-F238E27FC236}">
                <a16:creationId xmlns:a16="http://schemas.microsoft.com/office/drawing/2014/main" id="{FBFD7DA1-2F19-30DC-8D73-EB75973C11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4" y="384841"/>
            <a:ext cx="4599321" cy="344949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3CDDFCA-EAD8-F372-C116-B3738EB275C1}"/>
              </a:ext>
            </a:extLst>
          </p:cNvPr>
          <p:cNvSpPr txBox="1"/>
          <p:nvPr/>
        </p:nvSpPr>
        <p:spPr>
          <a:xfrm>
            <a:off x="1818662" y="2596385"/>
            <a:ext cx="9585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ShH1.2</a:t>
            </a:r>
          </a:p>
        </p:txBody>
      </p:sp>
      <p:pic>
        <p:nvPicPr>
          <p:cNvPr id="7" name="図 6" descr="写真, 座る, テーブル, 古い が含まれている画像&#10;&#10;自動的に生成された説明">
            <a:extLst>
              <a:ext uri="{FF2B5EF4-FFF2-40B4-BE49-F238E27FC236}">
                <a16:creationId xmlns:a16="http://schemas.microsoft.com/office/drawing/2014/main" id="{32818EB6-9DAD-82D2-3DFE-F35FECDC2E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44" y="4025865"/>
            <a:ext cx="3064126" cy="229809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E106E98-588D-C7CB-0333-8F8A7A454DD7}"/>
              </a:ext>
            </a:extLst>
          </p:cNvPr>
          <p:cNvSpPr txBox="1"/>
          <p:nvPr/>
        </p:nvSpPr>
        <p:spPr>
          <a:xfrm>
            <a:off x="1006135" y="5627025"/>
            <a:ext cx="6456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200" dirty="0">
                <a:solidFill>
                  <a:schemeClr val="bg1"/>
                </a:solidFill>
              </a:rPr>
              <a:t>ShH1.</a:t>
            </a:r>
            <a:r>
              <a:rPr lang="en-US" altLang="ja-JP" sz="1200" dirty="0">
                <a:solidFill>
                  <a:schemeClr val="bg1"/>
                </a:solidFill>
              </a:rPr>
              <a:t>3</a:t>
            </a:r>
            <a:endParaRPr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F1B0B1E-017C-3DC9-847E-6C9A15F0DD28}"/>
              </a:ext>
            </a:extLst>
          </p:cNvPr>
          <p:cNvSpPr txBox="1"/>
          <p:nvPr/>
        </p:nvSpPr>
        <p:spPr>
          <a:xfrm>
            <a:off x="1850572" y="5627025"/>
            <a:ext cx="6456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</a:rPr>
              <a:t>Actin</a:t>
            </a:r>
            <a:endParaRPr lang="ja-JP" altLang="en-US" sz="1200" dirty="0">
              <a:solidFill>
                <a:schemeClr val="bg1"/>
              </a:solidFill>
            </a:endParaRPr>
          </a:p>
        </p:txBody>
      </p:sp>
      <p:pic>
        <p:nvPicPr>
          <p:cNvPr id="11" name="図 10" descr="座る, 写真, フロント, 電車 が含まれている画像&#10;&#10;自動的に生成された説明">
            <a:extLst>
              <a:ext uri="{FF2B5EF4-FFF2-40B4-BE49-F238E27FC236}">
                <a16:creationId xmlns:a16="http://schemas.microsoft.com/office/drawing/2014/main" id="{4FB22881-2FBD-814D-B2B5-954459CBBB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44" y="6438650"/>
            <a:ext cx="4391804" cy="3293854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67642B3-4ADF-FAA9-ECAD-B5E8746BEBA6}"/>
              </a:ext>
            </a:extLst>
          </p:cNvPr>
          <p:cNvSpPr txBox="1"/>
          <p:nvPr/>
        </p:nvSpPr>
        <p:spPr>
          <a:xfrm>
            <a:off x="1651807" y="8558946"/>
            <a:ext cx="9585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ShH1.</a:t>
            </a:r>
            <a:r>
              <a:rPr lang="en-US" altLang="ja-JP" dirty="0">
                <a:solidFill>
                  <a:schemeClr val="bg1"/>
                </a:solidFill>
              </a:rPr>
              <a:t>4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A7DD81-FA28-BF0A-189D-CAC5D13D69BF}"/>
              </a:ext>
            </a:extLst>
          </p:cNvPr>
          <p:cNvSpPr txBox="1"/>
          <p:nvPr/>
        </p:nvSpPr>
        <p:spPr>
          <a:xfrm>
            <a:off x="4637802" y="8337176"/>
            <a:ext cx="18705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s of </a:t>
            </a:r>
            <a:r>
              <a:rPr kumimoji="1"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pplementary Figure 4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09637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白黒の写真にテキストが書いてある&#10;&#10;低い精度で自動的に生成された説明">
            <a:extLst>
              <a:ext uri="{FF2B5EF4-FFF2-40B4-BE49-F238E27FC236}">
                <a16:creationId xmlns:a16="http://schemas.microsoft.com/office/drawing/2014/main" id="{DF1CFD34-689A-8828-4C09-41A7DA6586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59" y="761361"/>
            <a:ext cx="4782670" cy="3587003"/>
          </a:xfrm>
          <a:prstGeom prst="rect">
            <a:avLst/>
          </a:prstGeom>
        </p:spPr>
      </p:pic>
      <p:pic>
        <p:nvPicPr>
          <p:cNvPr id="5" name="図 4" descr="白黒の写真に文字が入っている&#10;&#10;低い精度で自動的に生成された説明">
            <a:extLst>
              <a:ext uri="{FF2B5EF4-FFF2-40B4-BE49-F238E27FC236}">
                <a16:creationId xmlns:a16="http://schemas.microsoft.com/office/drawing/2014/main" id="{A5DDB748-C616-A3A5-B659-45A307396D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59" y="4510251"/>
            <a:ext cx="4782670" cy="358700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3DFA81-C6F1-8EB7-C5B6-407B38C70166}"/>
              </a:ext>
            </a:extLst>
          </p:cNvPr>
          <p:cNvSpPr txBox="1"/>
          <p:nvPr/>
        </p:nvSpPr>
        <p:spPr>
          <a:xfrm>
            <a:off x="2746402" y="7506233"/>
            <a:ext cx="9585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ShH</a:t>
            </a:r>
            <a:r>
              <a:rPr lang="en-US" altLang="ja-JP" dirty="0">
                <a:solidFill>
                  <a:schemeClr val="bg1"/>
                </a:solidFill>
              </a:rPr>
              <a:t>4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FFEF154-BFEC-6268-3AB9-BA307B946D57}"/>
              </a:ext>
            </a:extLst>
          </p:cNvPr>
          <p:cNvSpPr txBox="1"/>
          <p:nvPr/>
        </p:nvSpPr>
        <p:spPr>
          <a:xfrm>
            <a:off x="2691332" y="3347891"/>
            <a:ext cx="9585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chemeClr val="bg1"/>
                </a:solidFill>
              </a:rPr>
              <a:t>MRP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D509BD2-AC04-B808-0C8F-6B6C2F227A11}"/>
              </a:ext>
            </a:extLst>
          </p:cNvPr>
          <p:cNvSpPr txBox="1"/>
          <p:nvPr/>
        </p:nvSpPr>
        <p:spPr>
          <a:xfrm>
            <a:off x="888149" y="8259141"/>
            <a:ext cx="4782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s of </a:t>
            </a:r>
            <a:r>
              <a:rPr kumimoji="1"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pplementary Figure 4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2368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B7684D78-7FAD-D794-ADD9-B45FB49388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5979" y="227319"/>
            <a:ext cx="3350719" cy="446762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3164C99-1833-3C30-7472-0295ADA2D16D}"/>
              </a:ext>
            </a:extLst>
          </p:cNvPr>
          <p:cNvSpPr txBox="1"/>
          <p:nvPr/>
        </p:nvSpPr>
        <p:spPr>
          <a:xfrm>
            <a:off x="1836482" y="2345715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H1.1a 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4201B07-132F-08DD-FBDD-FF8FEB221D46}"/>
              </a:ext>
            </a:extLst>
          </p:cNvPr>
          <p:cNvSpPr txBox="1"/>
          <p:nvPr/>
        </p:nvSpPr>
        <p:spPr>
          <a:xfrm>
            <a:off x="2180983" y="2345715"/>
            <a:ext cx="4876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H1.1b 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  <p:pic>
        <p:nvPicPr>
          <p:cNvPr id="9" name="図 8" descr="白黒の写真にテキストが書いてある&#10;&#10;低い精度で自動的に生成された説明">
            <a:extLst>
              <a:ext uri="{FF2B5EF4-FFF2-40B4-BE49-F238E27FC236}">
                <a16:creationId xmlns:a16="http://schemas.microsoft.com/office/drawing/2014/main" id="{F171439D-31AA-B459-0FEB-4F59585141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9660" y="5006790"/>
            <a:ext cx="5004013" cy="375301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9BB22CE-1BE5-05D1-11FE-E751810ADD0F}"/>
              </a:ext>
            </a:extLst>
          </p:cNvPr>
          <p:cNvSpPr txBox="1"/>
          <p:nvPr/>
        </p:nvSpPr>
        <p:spPr>
          <a:xfrm>
            <a:off x="2626347" y="7375619"/>
            <a:ext cx="905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ShH1.5</a:t>
            </a:r>
            <a:endParaRPr kumimoji="1" lang="ja-JP" altLang="en-US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4F51337-23E5-EEB0-47E9-EDF6FC749541}"/>
              </a:ext>
            </a:extLst>
          </p:cNvPr>
          <p:cNvSpPr txBox="1"/>
          <p:nvPr/>
        </p:nvSpPr>
        <p:spPr>
          <a:xfrm>
            <a:off x="1095462" y="8990319"/>
            <a:ext cx="4390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s of </a:t>
            </a:r>
            <a:r>
              <a:rPr kumimoji="1"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pplementary </a:t>
            </a:r>
            <a:r>
              <a:rPr lang="en-US" altLang="ja-JP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sz="1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gure S4.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6415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6</TotalTime>
  <Words>49</Words>
  <Application>Microsoft Office PowerPoint</Application>
  <PresentationFormat>A4 210 x 297 mm</PresentationFormat>
  <Paragraphs>1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伸哉 吉川</dc:creator>
  <cp:lastModifiedBy>伸哉 吉川</cp:lastModifiedBy>
  <cp:revision>2</cp:revision>
  <dcterms:created xsi:type="dcterms:W3CDTF">2023-11-28T03:20:26Z</dcterms:created>
  <dcterms:modified xsi:type="dcterms:W3CDTF">2023-11-28T06:47:11Z</dcterms:modified>
</cp:coreProperties>
</file>